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F107A00-64FC-4CFB-8AB2-FD1100ED07DD}" v="1" dt="2022-09-14T07:48:26.26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139" autoAdjust="0"/>
    <p:restoredTop sz="94660"/>
  </p:normalViewPr>
  <p:slideViewPr>
    <p:cSldViewPr snapToGrid="0" showGuides="1">
      <p:cViewPr>
        <p:scale>
          <a:sx n="120" d="100"/>
          <a:sy n="120" d="100"/>
        </p:scale>
        <p:origin x="2124" y="84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7000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7165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9486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5938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6172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2669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426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1947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5780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8196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4079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4592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CF0DAF42-9167-F1C6-B75F-7194FE3219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3197881"/>
              </p:ext>
            </p:extLst>
          </p:nvPr>
        </p:nvGraphicFramePr>
        <p:xfrm>
          <a:off x="559463" y="1426292"/>
          <a:ext cx="5739074" cy="7400322"/>
        </p:xfrm>
        <a:graphic>
          <a:graphicData uri="http://schemas.openxmlformats.org/drawingml/2006/table">
            <a:tbl>
              <a:tblPr/>
              <a:tblGrid>
                <a:gridCol w="1581635">
                  <a:extLst>
                    <a:ext uri="{9D8B030D-6E8A-4147-A177-3AD203B41FA5}">
                      <a16:colId xmlns:a16="http://schemas.microsoft.com/office/drawing/2014/main" val="593544079"/>
                    </a:ext>
                  </a:extLst>
                </a:gridCol>
                <a:gridCol w="813412">
                  <a:extLst>
                    <a:ext uri="{9D8B030D-6E8A-4147-A177-3AD203B41FA5}">
                      <a16:colId xmlns:a16="http://schemas.microsoft.com/office/drawing/2014/main" val="3079569088"/>
                    </a:ext>
                  </a:extLst>
                </a:gridCol>
                <a:gridCol w="881196">
                  <a:extLst>
                    <a:ext uri="{9D8B030D-6E8A-4147-A177-3AD203B41FA5}">
                      <a16:colId xmlns:a16="http://schemas.microsoft.com/office/drawing/2014/main" val="1711932776"/>
                    </a:ext>
                  </a:extLst>
                </a:gridCol>
                <a:gridCol w="1581635">
                  <a:extLst>
                    <a:ext uri="{9D8B030D-6E8A-4147-A177-3AD203B41FA5}">
                      <a16:colId xmlns:a16="http://schemas.microsoft.com/office/drawing/2014/main" val="3183812539"/>
                    </a:ext>
                  </a:extLst>
                </a:gridCol>
                <a:gridCol w="881196">
                  <a:extLst>
                    <a:ext uri="{9D8B030D-6E8A-4147-A177-3AD203B41FA5}">
                      <a16:colId xmlns:a16="http://schemas.microsoft.com/office/drawing/2014/main" val="2151059357"/>
                    </a:ext>
                  </a:extLst>
                </a:gridCol>
              </a:tblGrid>
              <a:tr h="32197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otal length of sequence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75,269,058 bp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otal length of sequence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1,035,364 bp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6736380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otal number of sequences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82,621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otal number of sequences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6,621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383338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30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,929 bp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30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,754 bp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7866163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50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,260 bp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50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,791 bp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2212526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edian contig length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537 bp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edian contig length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882 bp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2296618"/>
                  </a:ext>
                </a:extLst>
              </a:tr>
              <a:tr h="20335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C %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55.40%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C %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54.60%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82580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endParaRPr lang="ko-KR" altLang="en-US" sz="3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3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3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3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3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054713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ength (bp)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eq #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ength (bp)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eq #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5133716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-999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59,107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-999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9,173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8174097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000-1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6,868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000-1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,794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6035393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000-2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,116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000-2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,488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6246171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000-3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,417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000-3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604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3143693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000-4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558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000-4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57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9946756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5000-5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58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5000-5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43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7272142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6000-6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04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6000-6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9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5827236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7000-7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68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7000-7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5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1064947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8000-8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5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8000-8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5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2457186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9000-9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3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9000-9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2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2586673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0000-10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1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0000-10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9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2960520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1000-11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0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1000-11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5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1600787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2000-12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2000-12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214208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3000-13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5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3000-13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7658977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4000-14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4000-14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0803527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5000-15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5000-15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6078123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6000-16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6000-16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7466547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7000-17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7000-17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4370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8000-18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8000-18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5409530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9000-19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9000-19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4559185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0000-20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0000-20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3656084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1000-21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1000-21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8239453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2000-22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2000-22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2322418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3000-23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3000-23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9762040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4000-24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6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4000-24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9427851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5000-25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7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5000-25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7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1423846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6000-26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6000-26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636995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7000-27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7000-27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3881567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8000-28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8000-28999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</a:t>
                      </a:r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5658569"/>
                  </a:ext>
                </a:extLst>
              </a:tr>
              <a:tr h="19488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9000-30000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</a:t>
                      </a:r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34" charset="-127"/>
                        <a:ea typeface="맑은 고딕" panose="020B0503020000020004" pitchFamily="34" charset="-127"/>
                      </a:endParaRP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9000-30000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rtl="0" fontAlgn="ctr"/>
                      <a:r>
                        <a:rPr lang="ko-KR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                      </a:t>
                      </a:r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- </a:t>
                      </a:r>
                    </a:p>
                  </a:txBody>
                  <a:tcPr marL="8473" marR="8473" marT="84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6942670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B91BAEA0-C5B2-8AC1-848A-8694AD38D9B8}"/>
              </a:ext>
            </a:extLst>
          </p:cNvPr>
          <p:cNvSpPr txBox="1"/>
          <p:nvPr/>
        </p:nvSpPr>
        <p:spPr>
          <a:xfrm>
            <a:off x="446671" y="612251"/>
            <a:ext cx="6094602" cy="455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S3 Table. </a:t>
            </a:r>
            <a:r>
              <a:rPr lang="en-US" altLang="ko-KR" sz="14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de novo</a:t>
            </a:r>
            <a:r>
              <a:rPr lang="en-US" altLang="ko-KR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 assembly of red mite sequences.</a:t>
            </a:r>
            <a:endParaRPr lang="ko-KR" altLang="ko-KR" sz="1400" dirty="0">
              <a:effectLst/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9AA18D2-2475-5763-5E6E-BE9578F6CB61}"/>
              </a:ext>
            </a:extLst>
          </p:cNvPr>
          <p:cNvSpPr txBox="1"/>
          <p:nvPr/>
        </p:nvSpPr>
        <p:spPr>
          <a:xfrm>
            <a:off x="451900" y="1026503"/>
            <a:ext cx="2665011" cy="3776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(</a:t>
            </a:r>
            <a:r>
              <a:rPr lang="en-US" altLang="ko-KR" sz="1100" b="1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a)</a:t>
            </a:r>
            <a:r>
              <a:rPr lang="ko-KR" altLang="en-US" sz="1100" b="1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 </a:t>
            </a:r>
            <a:r>
              <a:rPr lang="en-US" altLang="ko-KR" sz="1100" b="1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Total sequences</a:t>
            </a:r>
            <a:endParaRPr lang="ko-KR" altLang="ko-KR" sz="1100" dirty="0">
              <a:effectLst/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C1036E3-2717-4E64-1FCD-5A541858C87C}"/>
              </a:ext>
            </a:extLst>
          </p:cNvPr>
          <p:cNvSpPr txBox="1"/>
          <p:nvPr/>
        </p:nvSpPr>
        <p:spPr>
          <a:xfrm>
            <a:off x="3725185" y="1024617"/>
            <a:ext cx="2665011" cy="3776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(b</a:t>
            </a:r>
            <a:r>
              <a:rPr lang="en-US" altLang="ko-KR" sz="1100" b="1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)</a:t>
            </a:r>
            <a:r>
              <a:rPr lang="ko-KR" altLang="en-US" sz="1100" b="1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 </a:t>
            </a:r>
            <a:r>
              <a:rPr lang="en-US" altLang="ko-KR" sz="1100" b="1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Sequences for coding region</a:t>
            </a:r>
            <a:endParaRPr lang="ko-KR" altLang="ko-KR" sz="1100" dirty="0">
              <a:effectLst/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32418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</TotalTime>
  <Words>267</Words>
  <Application>Microsoft Office PowerPoint</Application>
  <PresentationFormat>와이드스크린</PresentationFormat>
  <Paragraphs>15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굴림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소은</dc:creator>
  <cp:lastModifiedBy>김재수</cp:lastModifiedBy>
  <cp:revision>4</cp:revision>
  <dcterms:created xsi:type="dcterms:W3CDTF">2022-09-14T06:04:29Z</dcterms:created>
  <dcterms:modified xsi:type="dcterms:W3CDTF">2023-01-06T05:14:17Z</dcterms:modified>
</cp:coreProperties>
</file>